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32" autoAdjust="0"/>
    <p:restoredTop sz="94660"/>
  </p:normalViewPr>
  <p:slideViewPr>
    <p:cSldViewPr snapToGrid="0">
      <p:cViewPr varScale="1">
        <p:scale>
          <a:sx n="166" d="100"/>
          <a:sy n="166" d="100"/>
        </p:scale>
        <p:origin x="1338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9544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5181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747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4861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9834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1468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084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8987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873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037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7857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A0A745-D015-441D-98EE-D075F88F0BCC}" type="datetimeFigureOut">
              <a:rPr lang="de-DE" smtClean="0"/>
              <a:t>08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991A1-5819-48C7-A7C4-34979F1403D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1386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312543" y="770627"/>
            <a:ext cx="2869722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tal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vitatio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1.600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sons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firmed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VID-19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3312543" y="1688814"/>
            <a:ext cx="2869720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525: Clinical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aminatio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rvey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3312543" y="2252437"/>
            <a:ext cx="2869720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525: Follow-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tal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rvey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6205268" y="2676281"/>
            <a:ext cx="2139352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9: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deliverable</a:t>
            </a:r>
            <a:endParaRPr lang="de-DE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4: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ticipatio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fused</a:t>
            </a:r>
            <a:endParaRPr lang="de-DE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41: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onse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3312543" y="3393543"/>
            <a:ext cx="2912853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361: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turned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uestionnaires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312543" y="4259179"/>
            <a:ext cx="2912853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310: Non-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spitalized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6225396" y="3813849"/>
            <a:ext cx="2139352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50: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spitalized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312543" y="5401917"/>
            <a:ext cx="2892723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304: Analysis sample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6205268" y="4654461"/>
            <a:ext cx="2139352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6: Time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VID-19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gnosis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sline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aminatio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&lt; 30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Gerade Verbindung mit Pfeil 13"/>
          <p:cNvCxnSpPr/>
          <p:nvPr/>
        </p:nvCxnSpPr>
        <p:spPr>
          <a:xfrm>
            <a:off x="3007743" y="770627"/>
            <a:ext cx="11502" cy="48480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2050210" y="855699"/>
            <a:ext cx="969035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ctober</a:t>
            </a:r>
            <a:r>
              <a:rPr lang="de-DE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020</a:t>
            </a:r>
            <a:endParaRPr lang="de-DE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1141561" y="1652345"/>
            <a:ext cx="1877684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vember 2020 – May 2021</a:t>
            </a:r>
            <a:endParaRPr lang="de-DE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2038708" y="2252437"/>
            <a:ext cx="969035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uni 2022</a:t>
            </a:r>
            <a:endParaRPr lang="de-DE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1984074" y="3393543"/>
            <a:ext cx="1023669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de-DE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vember 2022</a:t>
            </a:r>
            <a:endParaRPr lang="de-DE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6225396" y="1318657"/>
            <a:ext cx="2139352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75: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lang="de-DE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onse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Gerade Verbindung mit Pfeil 2"/>
          <p:cNvCxnSpPr>
            <a:stCxn id="4" idx="2"/>
            <a:endCxn id="5" idx="0"/>
          </p:cNvCxnSpPr>
          <p:nvPr/>
        </p:nvCxnSpPr>
        <p:spPr>
          <a:xfrm flipH="1">
            <a:off x="4747403" y="1201514"/>
            <a:ext cx="1" cy="4873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>
            <a:stCxn id="5" idx="2"/>
            <a:endCxn id="6" idx="0"/>
          </p:cNvCxnSpPr>
          <p:nvPr/>
        </p:nvCxnSpPr>
        <p:spPr>
          <a:xfrm>
            <a:off x="4747403" y="1950424"/>
            <a:ext cx="0" cy="30201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 flipH="1">
            <a:off x="4747403" y="2512415"/>
            <a:ext cx="2" cy="81914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>
            <a:off x="4733028" y="3651266"/>
            <a:ext cx="14375" cy="5597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 flipH="1">
            <a:off x="4733028" y="4534649"/>
            <a:ext cx="2" cy="81914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mit Pfeil 29"/>
          <p:cNvCxnSpPr/>
          <p:nvPr/>
        </p:nvCxnSpPr>
        <p:spPr>
          <a:xfrm flipV="1">
            <a:off x="4740215" y="2948334"/>
            <a:ext cx="1465051" cy="1385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/>
          <p:cNvCxnSpPr/>
          <p:nvPr/>
        </p:nvCxnSpPr>
        <p:spPr>
          <a:xfrm flipV="1">
            <a:off x="4740214" y="1420495"/>
            <a:ext cx="1465051" cy="1385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mit Pfeil 33"/>
          <p:cNvCxnSpPr/>
          <p:nvPr/>
        </p:nvCxnSpPr>
        <p:spPr>
          <a:xfrm flipV="1">
            <a:off x="4747403" y="3928658"/>
            <a:ext cx="1465051" cy="1385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/>
          <p:cNvCxnSpPr/>
          <p:nvPr/>
        </p:nvCxnSpPr>
        <p:spPr>
          <a:xfrm flipV="1">
            <a:off x="4729429" y="4940564"/>
            <a:ext cx="1465051" cy="1385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464445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5</Words>
  <Application>Microsoft Office PowerPoint</Application>
  <PresentationFormat>Bildschirmpräsentation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nge Kirchberger</dc:creator>
  <cp:lastModifiedBy>Inge Kirchberger</cp:lastModifiedBy>
  <cp:revision>9</cp:revision>
  <dcterms:created xsi:type="dcterms:W3CDTF">2023-02-21T10:20:42Z</dcterms:created>
  <dcterms:modified xsi:type="dcterms:W3CDTF">2023-05-08T11:47:26Z</dcterms:modified>
</cp:coreProperties>
</file>